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9B7B19-9CD4-4B0B-A689-A3C0890ECF5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6B2B38-696E-40F7-A631-52F609489F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36779F-F89B-425F-88AA-781B1B83502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1CE6F8-749B-49AF-A015-2F6CA46107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285E05-BDA7-49F7-8894-6327A1535B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DB182E-4E39-45E2-909F-2D62BB4B82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59B250-7484-4CAD-AAF0-9BA0687DED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6751BA-3A7D-459C-B899-DD38996492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648426-4368-4DA8-A9EF-E66C6C2218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E3C7AA-255E-4E38-B48D-44E5EB1504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13E752-5497-4FC0-B809-01135E2729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1A5132-C02E-455A-9319-704C15AF52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A6311E-C6D0-4FDD-B71B-54576A9E3D2E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グループ化 1"/>
          <p:cNvGrpSpPr/>
          <p:nvPr/>
        </p:nvGrpSpPr>
        <p:grpSpPr>
          <a:xfrm>
            <a:off x="925200" y="684360"/>
            <a:ext cx="5388120" cy="8311320"/>
            <a:chOff x="925200" y="684360"/>
            <a:chExt cx="5388120" cy="8311320"/>
          </a:xfrm>
        </p:grpSpPr>
        <p:sp>
          <p:nvSpPr>
            <p:cNvPr id="42" name="直線コネクタ 7"/>
            <p:cNvSpPr/>
            <p:nvPr/>
          </p:nvSpPr>
          <p:spPr>
            <a:xfrm flipV="1">
              <a:off x="2581200" y="6973560"/>
              <a:ext cx="0" cy="360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直線コネクタ 8"/>
            <p:cNvSpPr/>
            <p:nvPr/>
          </p:nvSpPr>
          <p:spPr>
            <a:xfrm>
              <a:off x="2016000" y="6594480"/>
              <a:ext cx="1425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直線コネクタ 9"/>
            <p:cNvSpPr/>
            <p:nvPr/>
          </p:nvSpPr>
          <p:spPr>
            <a:xfrm>
              <a:off x="2087280" y="6599520"/>
              <a:ext cx="0" cy="215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テキスト ボックス 14"/>
            <p:cNvSpPr/>
            <p:nvPr/>
          </p:nvSpPr>
          <p:spPr>
            <a:xfrm>
              <a:off x="5073480" y="1836720"/>
              <a:ext cx="1239840" cy="255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ff0000"/>
                  </a:solidFill>
                  <a:latin typeface="Symbol"/>
                  <a:ea typeface="Symbol"/>
                </a:rPr>
                <a:t></a:t>
              </a:r>
              <a:r>
                <a:rPr b="0" lang="en-US" sz="1600" spc="-1" strike="noStrike">
                  <a:solidFill>
                    <a:srgbClr val="ff0000"/>
                  </a:solidFill>
                  <a:latin typeface="Arial Black"/>
                </a:rPr>
                <a:t>III-tubul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2060"/>
                  </a:solidFill>
                  <a:latin typeface="Arial Black"/>
                </a:rPr>
                <a:t>DAPI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ff0000"/>
                  </a:solidFill>
                  <a:latin typeface="Arial Black"/>
                </a:rPr>
                <a:t>GFAP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2060"/>
                  </a:solidFill>
                  <a:latin typeface="Arial Black"/>
                </a:rPr>
                <a:t>DAPI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テキスト ボックス 13"/>
            <p:cNvSpPr/>
            <p:nvPr/>
          </p:nvSpPr>
          <p:spPr>
            <a:xfrm>
              <a:off x="1971360" y="992160"/>
              <a:ext cx="2305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 Black"/>
                </a:rPr>
                <a:t>shCtrl               shCHD7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テキスト ボックス 18"/>
            <p:cNvSpPr/>
            <p:nvPr/>
          </p:nvSpPr>
          <p:spPr>
            <a:xfrm>
              <a:off x="952200" y="684360"/>
              <a:ext cx="326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 Black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直線コネクタ 18"/>
            <p:cNvSpPr/>
            <p:nvPr/>
          </p:nvSpPr>
          <p:spPr>
            <a:xfrm flipV="1">
              <a:off x="1726920" y="6229080"/>
              <a:ext cx="0" cy="1368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直線コネクタ 19"/>
            <p:cNvSpPr/>
            <p:nvPr/>
          </p:nvSpPr>
          <p:spPr>
            <a:xfrm flipH="1">
              <a:off x="1596600" y="6235920"/>
              <a:ext cx="144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正方形/長方形 20"/>
            <p:cNvSpPr/>
            <p:nvPr/>
          </p:nvSpPr>
          <p:spPr>
            <a:xfrm>
              <a:off x="1942920" y="6664320"/>
              <a:ext cx="288720" cy="933120"/>
            </a:xfrm>
            <a:prstGeom prst="rect">
              <a:avLst/>
            </a:prstGeom>
            <a:solidFill>
              <a:srgbClr val="002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直線コネクタ 21"/>
            <p:cNvSpPr/>
            <p:nvPr/>
          </p:nvSpPr>
          <p:spPr>
            <a:xfrm flipH="1">
              <a:off x="1582200" y="6554880"/>
              <a:ext cx="144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直線コネクタ 22"/>
            <p:cNvSpPr/>
            <p:nvPr/>
          </p:nvSpPr>
          <p:spPr>
            <a:xfrm flipH="1">
              <a:off x="1586880" y="6910560"/>
              <a:ext cx="144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直線コネクタ 23"/>
            <p:cNvSpPr/>
            <p:nvPr/>
          </p:nvSpPr>
          <p:spPr>
            <a:xfrm flipH="1">
              <a:off x="1591560" y="7256520"/>
              <a:ext cx="144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正方形/長方形 24"/>
            <p:cNvSpPr/>
            <p:nvPr/>
          </p:nvSpPr>
          <p:spPr>
            <a:xfrm>
              <a:off x="2447640" y="7112160"/>
              <a:ext cx="287280" cy="48564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直線コネクタ 25"/>
            <p:cNvSpPr/>
            <p:nvPr/>
          </p:nvSpPr>
          <p:spPr>
            <a:xfrm>
              <a:off x="2514600" y="6967800"/>
              <a:ext cx="1425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テキスト ボックス 42"/>
            <p:cNvSpPr/>
            <p:nvPr/>
          </p:nvSpPr>
          <p:spPr>
            <a:xfrm>
              <a:off x="1877400" y="7686720"/>
              <a:ext cx="1072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Black"/>
                </a:rPr>
                <a:t>shCtrl  shCHD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テキスト ボックス 43"/>
            <p:cNvSpPr/>
            <p:nvPr/>
          </p:nvSpPr>
          <p:spPr>
            <a:xfrm>
              <a:off x="1345680" y="6129360"/>
              <a:ext cx="296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Black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正方形/長方形 44"/>
            <p:cNvSpPr/>
            <p:nvPr/>
          </p:nvSpPr>
          <p:spPr>
            <a:xfrm>
              <a:off x="1336320" y="6454800"/>
              <a:ext cx="296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Black"/>
                </a:rPr>
                <a:t>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テキスト ボックス 46"/>
            <p:cNvSpPr/>
            <p:nvPr/>
          </p:nvSpPr>
          <p:spPr>
            <a:xfrm>
              <a:off x="1345680" y="6805800"/>
              <a:ext cx="296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Black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テキスト ボックス 47"/>
            <p:cNvSpPr/>
            <p:nvPr/>
          </p:nvSpPr>
          <p:spPr>
            <a:xfrm>
              <a:off x="1373400" y="7156440"/>
              <a:ext cx="238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Black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テキスト ボックス 48"/>
            <p:cNvSpPr/>
            <p:nvPr/>
          </p:nvSpPr>
          <p:spPr>
            <a:xfrm>
              <a:off x="1374120" y="7506000"/>
              <a:ext cx="238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Black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テキスト ボックス 49"/>
            <p:cNvSpPr/>
            <p:nvPr/>
          </p:nvSpPr>
          <p:spPr>
            <a:xfrm>
              <a:off x="1842120" y="5724720"/>
              <a:ext cx="123984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 Black"/>
                </a:rPr>
                <a:t>III-tubul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直線コネクタ 33"/>
            <p:cNvSpPr/>
            <p:nvPr/>
          </p:nvSpPr>
          <p:spPr>
            <a:xfrm flipV="1">
              <a:off x="4748400" y="6233760"/>
              <a:ext cx="0" cy="360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直線コネクタ 34"/>
            <p:cNvSpPr/>
            <p:nvPr/>
          </p:nvSpPr>
          <p:spPr>
            <a:xfrm>
              <a:off x="4162320" y="6229440"/>
              <a:ext cx="144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直線コネクタ 35"/>
            <p:cNvSpPr/>
            <p:nvPr/>
          </p:nvSpPr>
          <p:spPr>
            <a:xfrm>
              <a:off x="4233960" y="6234120"/>
              <a:ext cx="0" cy="215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直線コネクタ 36"/>
            <p:cNvSpPr/>
            <p:nvPr/>
          </p:nvSpPr>
          <p:spPr>
            <a:xfrm flipV="1">
              <a:off x="3894120" y="6229080"/>
              <a:ext cx="0" cy="1368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直線コネクタ 37"/>
            <p:cNvSpPr/>
            <p:nvPr/>
          </p:nvSpPr>
          <p:spPr>
            <a:xfrm flipH="1">
              <a:off x="3762000" y="6235920"/>
              <a:ext cx="144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正方形/長方形 38"/>
            <p:cNvSpPr/>
            <p:nvPr/>
          </p:nvSpPr>
          <p:spPr>
            <a:xfrm>
              <a:off x="4110120" y="6350040"/>
              <a:ext cx="287280" cy="1247760"/>
            </a:xfrm>
            <a:prstGeom prst="rect">
              <a:avLst/>
            </a:prstGeom>
            <a:solidFill>
              <a:srgbClr val="002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直線コネクタ 40"/>
            <p:cNvSpPr/>
            <p:nvPr/>
          </p:nvSpPr>
          <p:spPr>
            <a:xfrm flipH="1">
              <a:off x="3749400" y="6516720"/>
              <a:ext cx="144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直線コネクタ 41"/>
            <p:cNvSpPr/>
            <p:nvPr/>
          </p:nvSpPr>
          <p:spPr>
            <a:xfrm flipH="1">
              <a:off x="3752640" y="6780240"/>
              <a:ext cx="144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直線コネクタ 42"/>
            <p:cNvSpPr/>
            <p:nvPr/>
          </p:nvSpPr>
          <p:spPr>
            <a:xfrm flipH="1">
              <a:off x="3749400" y="7059600"/>
              <a:ext cx="144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直線コネクタ 43"/>
            <p:cNvSpPr/>
            <p:nvPr/>
          </p:nvSpPr>
          <p:spPr>
            <a:xfrm flipH="1">
              <a:off x="3758760" y="7337520"/>
              <a:ext cx="144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正方形/長方形 44"/>
            <p:cNvSpPr/>
            <p:nvPr/>
          </p:nvSpPr>
          <p:spPr>
            <a:xfrm>
              <a:off x="4613400" y="6293160"/>
              <a:ext cx="288720" cy="130464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直線コネクタ 45"/>
            <p:cNvSpPr/>
            <p:nvPr/>
          </p:nvSpPr>
          <p:spPr>
            <a:xfrm>
              <a:off x="4676760" y="6229440"/>
              <a:ext cx="144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テキスト ボックス 63"/>
            <p:cNvSpPr/>
            <p:nvPr/>
          </p:nvSpPr>
          <p:spPr>
            <a:xfrm>
              <a:off x="4076280" y="7669440"/>
              <a:ext cx="1072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Black"/>
                </a:rPr>
                <a:t>shCtrl  shCHD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テキスト ボックス 64"/>
            <p:cNvSpPr/>
            <p:nvPr/>
          </p:nvSpPr>
          <p:spPr>
            <a:xfrm>
              <a:off x="3444480" y="6129360"/>
              <a:ext cx="354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Black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正方形/長方形 65"/>
            <p:cNvSpPr/>
            <p:nvPr/>
          </p:nvSpPr>
          <p:spPr>
            <a:xfrm>
              <a:off x="3502440" y="6402600"/>
              <a:ext cx="296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Black"/>
                </a:rPr>
                <a:t>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テキスト ボックス 66"/>
            <p:cNvSpPr/>
            <p:nvPr/>
          </p:nvSpPr>
          <p:spPr>
            <a:xfrm>
              <a:off x="3512160" y="6670800"/>
              <a:ext cx="296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Black"/>
                </a:rPr>
                <a:t>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テキスト ボックス 67"/>
            <p:cNvSpPr/>
            <p:nvPr/>
          </p:nvSpPr>
          <p:spPr>
            <a:xfrm>
              <a:off x="3512160" y="6945480"/>
              <a:ext cx="296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Black"/>
                </a:rPr>
                <a:t>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テキスト ボックス 68"/>
            <p:cNvSpPr/>
            <p:nvPr/>
          </p:nvSpPr>
          <p:spPr>
            <a:xfrm>
              <a:off x="3502440" y="7237440"/>
              <a:ext cx="296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Black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テキスト ボックス 69"/>
            <p:cNvSpPr/>
            <p:nvPr/>
          </p:nvSpPr>
          <p:spPr>
            <a:xfrm>
              <a:off x="3540600" y="7506000"/>
              <a:ext cx="238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Black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テキスト ボックス 70"/>
            <p:cNvSpPr/>
            <p:nvPr/>
          </p:nvSpPr>
          <p:spPr>
            <a:xfrm>
              <a:off x="4014720" y="5724720"/>
              <a:ext cx="1023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 Black"/>
                </a:rPr>
                <a:t>GFAP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テキスト ボックス 74"/>
            <p:cNvSpPr/>
            <p:nvPr/>
          </p:nvSpPr>
          <p:spPr>
            <a:xfrm>
              <a:off x="925200" y="5292720"/>
              <a:ext cx="3301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 Black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直線コネクタ 59"/>
            <p:cNvSpPr/>
            <p:nvPr/>
          </p:nvSpPr>
          <p:spPr>
            <a:xfrm>
              <a:off x="1588680" y="7597800"/>
              <a:ext cx="14400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5" name="Picture 2" descr="C:\Users\Shigeki\Desktop\shCtrl-bIII-12.tif"/>
            <p:cNvPicPr/>
            <p:nvPr/>
          </p:nvPicPr>
          <p:blipFill>
            <a:blip r:embed="rId1"/>
            <a:stretch/>
          </p:blipFill>
          <p:spPr>
            <a:xfrm>
              <a:off x="1298160" y="1332000"/>
              <a:ext cx="1800360" cy="180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6" name="直線コネクタ 63"/>
            <p:cNvSpPr/>
            <p:nvPr/>
          </p:nvSpPr>
          <p:spPr>
            <a:xfrm>
              <a:off x="2738160" y="3060720"/>
              <a:ext cx="28728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テキスト ボックス 64"/>
            <p:cNvSpPr/>
            <p:nvPr/>
          </p:nvSpPr>
          <p:spPr>
            <a:xfrm>
              <a:off x="4431600" y="8688600"/>
              <a:ext cx="1791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Ohta S et al., Fig.S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8" name="Picture 4" descr="C:\Users\Shigeki\Desktop\shCHD7-bIII-5-2.tif"/>
            <p:cNvPicPr/>
            <p:nvPr/>
          </p:nvPicPr>
          <p:blipFill>
            <a:blip r:embed="rId2"/>
            <a:stretch/>
          </p:blipFill>
          <p:spPr>
            <a:xfrm>
              <a:off x="3189240" y="1332000"/>
              <a:ext cx="1800360" cy="180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9" name="直線コネクタ 67"/>
            <p:cNvSpPr/>
            <p:nvPr/>
          </p:nvSpPr>
          <p:spPr>
            <a:xfrm>
              <a:off x="4610160" y="3060720"/>
              <a:ext cx="28872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0" name="Picture 6" descr="C:\Users\Shigeki\Desktop\shCtrl-6.tif"/>
            <p:cNvPicPr/>
            <p:nvPr/>
          </p:nvPicPr>
          <p:blipFill>
            <a:blip r:embed="rId3"/>
            <a:stretch/>
          </p:blipFill>
          <p:spPr>
            <a:xfrm>
              <a:off x="1279080" y="3224160"/>
              <a:ext cx="1817640" cy="1817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1" name="直線コネクタ 71"/>
            <p:cNvSpPr/>
            <p:nvPr/>
          </p:nvSpPr>
          <p:spPr>
            <a:xfrm>
              <a:off x="2738160" y="4991040"/>
              <a:ext cx="28728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2" name="Picture 7" descr="C:\Users\Shigeki\Desktop\shCHD7-15F.tif"/>
            <p:cNvPicPr/>
            <p:nvPr/>
          </p:nvPicPr>
          <p:blipFill>
            <a:blip r:embed="rId4"/>
            <a:stretch/>
          </p:blipFill>
          <p:spPr>
            <a:xfrm>
              <a:off x="3187800" y="3222720"/>
              <a:ext cx="1822320" cy="1822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3" name="直線コネクタ 73"/>
            <p:cNvSpPr/>
            <p:nvPr/>
          </p:nvSpPr>
          <p:spPr>
            <a:xfrm>
              <a:off x="4610160" y="4980240"/>
              <a:ext cx="28872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直線コネクタ 39"/>
            <p:cNvSpPr/>
            <p:nvPr/>
          </p:nvSpPr>
          <p:spPr>
            <a:xfrm>
              <a:off x="3754440" y="7597800"/>
              <a:ext cx="14400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直線コネクタ 77"/>
            <p:cNvSpPr/>
            <p:nvPr/>
          </p:nvSpPr>
          <p:spPr>
            <a:xfrm>
              <a:off x="2589120" y="7596360"/>
              <a:ext cx="0" cy="72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直線コネクタ 78"/>
            <p:cNvSpPr/>
            <p:nvPr/>
          </p:nvSpPr>
          <p:spPr>
            <a:xfrm>
              <a:off x="2076120" y="7596360"/>
              <a:ext cx="0" cy="72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直線コネクタ 79"/>
            <p:cNvSpPr/>
            <p:nvPr/>
          </p:nvSpPr>
          <p:spPr>
            <a:xfrm>
              <a:off x="4756320" y="7601040"/>
              <a:ext cx="0" cy="71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直線コネクタ 80"/>
            <p:cNvSpPr/>
            <p:nvPr/>
          </p:nvSpPr>
          <p:spPr>
            <a:xfrm>
              <a:off x="4253040" y="7601040"/>
              <a:ext cx="0" cy="71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テキスト ボックス 58"/>
            <p:cNvSpPr/>
            <p:nvPr/>
          </p:nvSpPr>
          <p:spPr>
            <a:xfrm>
              <a:off x="2434680" y="6823080"/>
              <a:ext cx="278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テキスト ボックス 1"/>
            <p:cNvSpPr/>
            <p:nvPr/>
          </p:nvSpPr>
          <p:spPr>
            <a:xfrm rot="16200000">
              <a:off x="-251640" y="5909040"/>
              <a:ext cx="307332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Black"/>
                </a:rPr>
                <a:t>Immunopositive cells/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Black"/>
                </a:rPr>
                <a:t>Field (%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正方形/長方形 2"/>
            <p:cNvSpPr/>
            <p:nvPr/>
          </p:nvSpPr>
          <p:spPr>
            <a:xfrm rot="16200000">
              <a:off x="1747080" y="5724720"/>
              <a:ext cx="342900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Black"/>
                </a:rPr>
                <a:t>Immunopsitive cells/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Black"/>
                </a:rPr>
                <a:t>Field (%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3-01T07:45:55Z</dcterms:created>
  <dc:creator>Shigeki</dc:creator>
  <dc:description/>
  <dc:language>en-US</dc:language>
  <cp:lastModifiedBy>大多茂樹</cp:lastModifiedBy>
  <dcterms:modified xsi:type="dcterms:W3CDTF">2016-11-01T05:45:01Z</dcterms:modified>
  <cp:revision>24</cp:revision>
  <dc:subject/>
  <dc:title>スライド 1</dc:title>
</cp:coreProperties>
</file>